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6173A-70D7-4EA3-BE46-155DA1E6906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837642-BFB0-402D-B6DF-EBC570DB1F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F14A4C-3E49-44A0-A834-552A4F37305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ACC61F-679D-4256-83DA-78F34ADACB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71F1E6-CC3B-48E6-A014-7EEB991F37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2F758A-49D8-4C52-92FC-21C7D61D0B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21D279-E862-44FA-BF00-E1E3A3540F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B4D1A2-FBF7-4D52-B81D-909160F351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51573F-55CD-4C95-B729-88564FA042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52916-9A70-4C62-9BD9-F8D01B4DDE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24B65-61AD-4DF1-B5BC-CD9E2D4CE34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38531-C3E2-48FA-8DA3-9CA32EDE39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99E4AEC-2D2C-4686-B83A-D592C0A489B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446040" y="1149480"/>
          <a:ext cx="8229600" cy="4800600"/>
        </p:xfrm>
        <a:graphic>
          <a:graphicData uri="http://schemas.openxmlformats.org/drawingml/2006/table">
            <a:tbl>
              <a:tblPr/>
              <a:tblGrid>
                <a:gridCol w="2109960"/>
                <a:gridCol w="1058760"/>
                <a:gridCol w="981000"/>
                <a:gridCol w="1020600"/>
                <a:gridCol w="1019520"/>
                <a:gridCol w="1020600"/>
                <a:gridCol w="1019160"/>
              </a:tblGrid>
              <a:tr h="26028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arget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onXpress_00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onXpress_0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onXpress_0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IonXpress_0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onXpress_0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onXpress_0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ERBB4_8_exon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ERBB4_7_exon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4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ERBB4_6_exon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3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0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ERBB4_5_exon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8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6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ERBB4_4_exon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8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1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04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ERBB4_3_exon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7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77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5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ERBB4_2_exon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5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8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ERBB4_1_exon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ON_EGFR_2A_exon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7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2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303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CHP2_EGFR_4_exon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9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553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1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3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CHP2_EGFR_5_exon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66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7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443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9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CCP_EGFR_6_exon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419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2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CHP2_EGFR_8_exon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ff0000"/>
                          </a:solidFill>
                          <a:latin typeface="Times New Roman"/>
                        </a:rPr>
                        <a:t>3985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1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3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PTEN_1_exon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31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0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68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PTEN_2_exon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0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13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PTEN_4_exon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70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3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5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PTEN_5_exon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7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5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0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8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7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PTEN_6_exon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5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49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28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2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9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716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PTEN_7_exon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0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1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5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52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6800"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HP2_PTEN_8_exon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6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4-06T12:47:47Z</dcterms:created>
  <dc:creator>chu</dc:creator>
  <dc:description/>
  <dc:language>en-US</dc:language>
  <cp:lastModifiedBy>chu</cp:lastModifiedBy>
  <cp:lastPrinted>2017-04-07T10:11:10Z</cp:lastPrinted>
  <dcterms:modified xsi:type="dcterms:W3CDTF">2018-02-16T14:44:02Z</dcterms:modified>
  <cp:revision>109</cp:revision>
  <dc:subject/>
  <dc:title>Diapositive 1</dc:title>
</cp:coreProperties>
</file>